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55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D286D-46C5-4A62-B510-521E8473E75D}" type="datetimeFigureOut">
              <a:rPr lang="en-US" smtClean="0"/>
              <a:pPr/>
              <a:t>4/1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B5037-1EF6-4030-B948-E7E828C43F5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l="5841" b="5263"/>
          <a:stretch>
            <a:fillRect/>
          </a:stretch>
        </p:blipFill>
        <p:spPr bwMode="auto">
          <a:xfrm>
            <a:off x="685800" y="1225446"/>
            <a:ext cx="3147098" cy="2342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 l="5597" b="5263"/>
          <a:stretch>
            <a:fillRect/>
          </a:stretch>
        </p:blipFill>
        <p:spPr bwMode="auto">
          <a:xfrm>
            <a:off x="4724400" y="1225446"/>
            <a:ext cx="3155253" cy="2342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3"/>
          <p:cNvSpPr/>
          <p:nvPr/>
        </p:nvSpPr>
        <p:spPr>
          <a:xfrm>
            <a:off x="0" y="0"/>
            <a:ext cx="200567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dditional file </a:t>
            </a:r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10</a:t>
            </a:r>
            <a:endParaRPr lang="en-US" sz="2000" dirty="0"/>
          </a:p>
        </p:txBody>
      </p:sp>
      <p:sp>
        <p:nvSpPr>
          <p:cNvPr id="5" name="Rectangle 4"/>
          <p:cNvSpPr/>
          <p:nvPr/>
        </p:nvSpPr>
        <p:spPr>
          <a:xfrm>
            <a:off x="311724" y="1039292"/>
            <a:ext cx="37382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)</a:t>
            </a:r>
            <a:endParaRPr lang="en-US" sz="1600" dirty="0"/>
          </a:p>
        </p:txBody>
      </p:sp>
      <p:sp>
        <p:nvSpPr>
          <p:cNvPr id="6" name="Rectangle 5"/>
          <p:cNvSpPr/>
          <p:nvPr/>
        </p:nvSpPr>
        <p:spPr>
          <a:xfrm>
            <a:off x="4419600" y="1041604"/>
            <a:ext cx="36420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)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1759536" y="3548390"/>
            <a:ext cx="13211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Mycelia Small RNA </a:t>
            </a:r>
            <a:endParaRPr lang="en-US" sz="11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795350" y="3548390"/>
            <a:ext cx="15584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Appressoria Small RNA </a:t>
            </a:r>
            <a:endParaRPr lang="en-US" sz="110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-242625" y="2159425"/>
            <a:ext cx="1356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Mycelia Microarray </a:t>
            </a:r>
            <a:endParaRPr lang="en-US" sz="1100" b="1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3808418" y="2159425"/>
            <a:ext cx="15616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Appressoria Microarray</a:t>
            </a:r>
            <a:endParaRPr lang="en-US" sz="11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4</TotalTime>
  <Words>17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fg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eonyee</dc:creator>
  <cp:lastModifiedBy>Cristiano C Nunes</cp:lastModifiedBy>
  <cp:revision>15</cp:revision>
  <dcterms:created xsi:type="dcterms:W3CDTF">2011-04-11T18:42:17Z</dcterms:created>
  <dcterms:modified xsi:type="dcterms:W3CDTF">2011-04-12T19:57:46Z</dcterms:modified>
</cp:coreProperties>
</file>